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669088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Style moyen 2 - Accentuation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327F97BB-C833-4FB7-BDE5-3F7075034690}" styleName="Style à thème 2 - Accentuation 5">
    <a:tblBg>
      <a:fillRef idx="3">
        <a:schemeClr val="accent5"/>
      </a:fillRef>
      <a:effectRef idx="3">
        <a:schemeClr val="accent5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5">
                <a:tint val="50000"/>
              </a:schemeClr>
            </a:lnRef>
          </a:left>
          <a:right>
            <a:lnRef idx="1">
              <a:schemeClr val="accent5">
                <a:tint val="50000"/>
              </a:schemeClr>
            </a:lnRef>
          </a:right>
          <a:top>
            <a:lnRef idx="1">
              <a:schemeClr val="accent5">
                <a:tint val="50000"/>
              </a:schemeClr>
            </a:lnRef>
          </a:top>
          <a:bottom>
            <a:lnRef idx="1">
              <a:schemeClr val="accent5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286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5606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1920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150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4936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026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1271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4440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125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602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6670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1877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6298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257668" y="6219011"/>
            <a:ext cx="5915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smtClean="0"/>
              <a:t>Table </a:t>
            </a:r>
            <a:r>
              <a:rPr lang="fr-FR" sz="1200" b="1" smtClean="0"/>
              <a:t>S2</a:t>
            </a:r>
            <a:r>
              <a:rPr lang="fr-FR" sz="1200" smtClean="0"/>
              <a:t>.  </a:t>
            </a:r>
            <a:r>
              <a:rPr lang="fr-FR" sz="1200" smtClean="0"/>
              <a:t>List of the primers used in this study.</a:t>
            </a:r>
            <a:endParaRPr lang="fr-FR" sz="1200"/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4627375"/>
              </p:ext>
            </p:extLst>
          </p:nvPr>
        </p:nvGraphicFramePr>
        <p:xfrm>
          <a:off x="1370557" y="1288871"/>
          <a:ext cx="4398065" cy="493014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854765">
                  <a:extLst>
                    <a:ext uri="{9D8B030D-6E8A-4147-A177-3AD203B41FA5}">
                      <a16:colId xmlns:a16="http://schemas.microsoft.com/office/drawing/2014/main" val="1294698135"/>
                    </a:ext>
                  </a:extLst>
                </a:gridCol>
                <a:gridCol w="2166056">
                  <a:extLst>
                    <a:ext uri="{9D8B030D-6E8A-4147-A177-3AD203B41FA5}">
                      <a16:colId xmlns:a16="http://schemas.microsoft.com/office/drawing/2014/main" val="2264862201"/>
                    </a:ext>
                  </a:extLst>
                </a:gridCol>
                <a:gridCol w="1377244">
                  <a:extLst>
                    <a:ext uri="{9D8B030D-6E8A-4147-A177-3AD203B41FA5}">
                      <a16:colId xmlns:a16="http://schemas.microsoft.com/office/drawing/2014/main" val="190057235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fr-FR" smtClean="0"/>
                        <a:t>Primers</a:t>
                      </a:r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mtClean="0"/>
                        <a:t>Sequence (5’-3’)</a:t>
                      </a:r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mtClean="0"/>
                        <a:t>Use</a:t>
                      </a:r>
                      <a:r>
                        <a:rPr lang="fr-FR" baseline="0" smtClean="0"/>
                        <a:t> of amplic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637623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436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smtClean="0"/>
                        <a:t>GAAAACACTAACAGAAATC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baseline="0" smtClean="0"/>
                        <a:t>Sequencing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4657054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437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CTGTTAAAGTTTTTTCATATC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aseline="0" smtClean="0"/>
                        <a:t>Sequencing</a:t>
                      </a:r>
                      <a:endParaRPr lang="fr-FR" sz="100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58998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480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ATCACAAAGACTTAGATTGAACAAAT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aseline="0" smtClean="0"/>
                        <a:t>Sequencing</a:t>
                      </a:r>
                      <a:endParaRPr lang="fr-FR" sz="100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503292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141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GAWWTCTGTTAAAGTTTTTTTC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smtClean="0"/>
                        <a:t>Sequencin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756321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143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TGGATATGTTCTACTTCCACTTCA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smtClean="0"/>
                        <a:t>Sequencin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8790892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479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AACAGTAATCACAAAGACTT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aseline="0" smtClean="0"/>
                        <a:t>Sequencing</a:t>
                      </a:r>
                      <a:endParaRPr lang="fr-FR" sz="100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13924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18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GCACGATGTGATGCAG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aseline="0" smtClean="0"/>
                        <a:t>Sequencing</a:t>
                      </a:r>
                      <a:endParaRPr lang="fr-FR" sz="100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67825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22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TTGGCTCTGCAGTCCCG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aseline="0" smtClean="0"/>
                        <a:t>Sequencing</a:t>
                      </a:r>
                      <a:endParaRPr lang="fr-FR" sz="100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245699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443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ATCATTCTGGACACCTCTTG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aseline="0" smtClean="0"/>
                        <a:t>Sequencing</a:t>
                      </a:r>
                      <a:endParaRPr lang="fr-FR" sz="100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958423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35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CTGAAAATCTTCAACAGTRATCA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aseline="0" smtClean="0"/>
                        <a:t>Sequencing</a:t>
                      </a:r>
                      <a:endParaRPr lang="fr-FR" sz="100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861193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34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CAGAGTAGCCACTCTCAC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aseline="0" smtClean="0"/>
                        <a:t>Sequencing</a:t>
                      </a:r>
                      <a:endParaRPr lang="fr-FR" sz="100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237218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21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AAGTTCTGGATTGGGTCTTTACA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Detection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0289440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22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TTGGCTCTGCAGTCCCG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Detection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018443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23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TCTTTACAGCGTGCTGAAGG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Detection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920389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24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TTGCAACTCTGACTATGGCC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Detection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14613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smtClean="0"/>
                        <a:t>oPVP5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CACAAGGACTGTGCTGCAT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Detection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11775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smtClean="0"/>
                        <a:t>oPVP5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TCAGCATTCCTTGTCAAGTTG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Detection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036337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46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TTCACTGATCAGGTTGCTCA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Detection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953497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000" smtClean="0"/>
                        <a:t>oPVP547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CTTCAGGTAAGCTCCAATGG</a:t>
                      </a:r>
                      <a:endParaRPr lang="fr-FR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smtClean="0"/>
                        <a:t>Detection</a:t>
                      </a:r>
                      <a:endParaRPr lang="fr-FR" sz="100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92572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41928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3</TotalTime>
  <Words>79</Words>
  <Application>Microsoft Office PowerPoint</Application>
  <PresentationFormat>Affichage à l'écran (4:3)</PresentationFormat>
  <Paragraphs>6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NS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IGARRE Laurent</dc:creator>
  <cp:lastModifiedBy>BIGARRE Laurent</cp:lastModifiedBy>
  <cp:revision>111</cp:revision>
  <cp:lastPrinted>2020-05-25T10:23:04Z</cp:lastPrinted>
  <dcterms:created xsi:type="dcterms:W3CDTF">2019-07-31T15:03:24Z</dcterms:created>
  <dcterms:modified xsi:type="dcterms:W3CDTF">2020-05-28T08:35:50Z</dcterms:modified>
</cp:coreProperties>
</file>